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906000" cy="6858000" type="A4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780" y="216"/>
      </p:cViewPr>
      <p:guideLst>
        <p:guide orient="horz" pos="2160"/>
        <p:guide pos="289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B94944-4589-4222-A66E-869EE70297C8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711200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AC0AE0-CBD2-486B-913F-BE992B2F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2653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AC0AE0-CBD2-486B-913F-BE992B2F2A4F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8781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8"/>
            <a:ext cx="84201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8556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916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780337" y="274641"/>
            <a:ext cx="2414588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36577" y="274641"/>
            <a:ext cx="7078663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7580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6636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1570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36577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448302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603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2994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7292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304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2" y="273053"/>
            <a:ext cx="5537728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5086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4285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D3303-32A1-45E5-8FB5-1EB81C804B7F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704A31-F67A-45AC-95CF-BD94BE265AF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1827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e 12"/>
          <p:cNvGrpSpPr/>
          <p:nvPr/>
        </p:nvGrpSpPr>
        <p:grpSpPr>
          <a:xfrm>
            <a:off x="4372685" y="2145283"/>
            <a:ext cx="3769496" cy="4599765"/>
            <a:chOff x="5213644" y="280667"/>
            <a:chExt cx="3769496" cy="4599765"/>
          </a:xfrm>
        </p:grpSpPr>
        <p:grpSp>
          <p:nvGrpSpPr>
            <p:cNvPr id="21" name="Groupe 20"/>
            <p:cNvGrpSpPr/>
            <p:nvPr/>
          </p:nvGrpSpPr>
          <p:grpSpPr>
            <a:xfrm>
              <a:off x="5313040" y="413300"/>
              <a:ext cx="3670100" cy="4467132"/>
              <a:chOff x="937667" y="674488"/>
              <a:chExt cx="3670100" cy="4467132"/>
            </a:xfrm>
          </p:grpSpPr>
          <p:pic>
            <p:nvPicPr>
              <p:cNvPr id="22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320" b="-1"/>
              <a:stretch/>
            </p:blipFill>
            <p:spPr bwMode="auto">
              <a:xfrm>
                <a:off x="1766991" y="1100098"/>
                <a:ext cx="2840776" cy="94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3" name="ZoneTexte 22"/>
              <p:cNvSpPr txBox="1"/>
              <p:nvPr/>
            </p:nvSpPr>
            <p:spPr>
              <a:xfrm>
                <a:off x="1879759" y="775394"/>
                <a:ext cx="78098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1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>
                  <a:defRPr/>
                </a:lvl2pPr>
                <a:lvl3pPr>
                  <a:defRPr/>
                </a:lvl3pPr>
                <a:lvl4pPr>
                  <a:defRPr/>
                </a:lvl4pPr>
                <a:lvl5pPr>
                  <a:defRPr/>
                </a:lvl5pPr>
                <a:lvl6pPr>
                  <a:defRPr/>
                </a:lvl6pPr>
                <a:lvl7pPr>
                  <a:defRPr/>
                </a:lvl7pPr>
                <a:lvl8pPr>
                  <a:defRPr/>
                </a:lvl8pPr>
                <a:lvl9pPr>
                  <a:defRPr/>
                </a:lvl9pPr>
              </a:lstStyle>
              <a:p>
                <a:r>
                  <a:rPr lang="fr-FR" dirty="0" smtClean="0"/>
                  <a:t>MLV_WT</a:t>
                </a:r>
                <a:endParaRPr lang="fr-FR" dirty="0"/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>
                <a:off x="2795207" y="775394"/>
                <a:ext cx="84350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1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FR" dirty="0" smtClean="0"/>
                  <a:t>MLV_ip12</a:t>
                </a:r>
                <a:endParaRPr lang="fr-FR" dirty="0"/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>
                <a:off x="3711291" y="674488"/>
                <a:ext cx="889987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1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FR" dirty="0" smtClean="0"/>
                  <a:t>MLV-ip12_</a:t>
                </a:r>
                <a:endParaRPr lang="fr-FR" dirty="0"/>
              </a:p>
              <a:p>
                <a:r>
                  <a:rPr lang="fr-FR" dirty="0"/>
                  <a:t>MS2coat</a:t>
                </a:r>
              </a:p>
            </p:txBody>
          </p:sp>
          <p:pic>
            <p:nvPicPr>
              <p:cNvPr id="26" name="Picture 3"/>
              <p:cNvPicPr>
                <a:picLocks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10"/>
              <a:stretch/>
            </p:blipFill>
            <p:spPr bwMode="auto">
              <a:xfrm>
                <a:off x="1767179" y="2133735"/>
                <a:ext cx="2840400" cy="94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7" name="Picture 4"/>
              <p:cNvPicPr>
                <a:picLocks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805" r="309"/>
              <a:stretch/>
            </p:blipFill>
            <p:spPr bwMode="auto">
              <a:xfrm>
                <a:off x="1767179" y="3162414"/>
                <a:ext cx="2840400" cy="94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8" name="Picture 5"/>
              <p:cNvPicPr>
                <a:picLocks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75"/>
              <a:stretch/>
            </p:blipFill>
            <p:spPr bwMode="auto">
              <a:xfrm>
                <a:off x="1767179" y="4194820"/>
                <a:ext cx="2840400" cy="94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" name="ZoneTexte 28"/>
              <p:cNvSpPr txBox="1"/>
              <p:nvPr/>
            </p:nvSpPr>
            <p:spPr>
              <a:xfrm>
                <a:off x="988964" y="1442693"/>
                <a:ext cx="7216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1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FR" dirty="0" smtClean="0"/>
                  <a:t>SGR</a:t>
                </a:r>
                <a:r>
                  <a:rPr lang="fr-FR" baseline="-25000" dirty="0" smtClean="0"/>
                  <a:t>JFH1</a:t>
                </a:r>
                <a:endParaRPr lang="fr-FR" baseline="-25000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942477" y="2391693"/>
                <a:ext cx="76815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2-6X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937667" y="3420371"/>
                <a:ext cx="77296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2-12X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937667" y="4452777"/>
                <a:ext cx="77296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2-24X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" name="ZoneTexte 34"/>
            <p:cNvSpPr txBox="1"/>
            <p:nvPr/>
          </p:nvSpPr>
          <p:spPr>
            <a:xfrm>
              <a:off x="5213644" y="28066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fr-FR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4" name="ZoneTexte 33"/>
          <p:cNvSpPr txBox="1"/>
          <p:nvPr/>
        </p:nvSpPr>
        <p:spPr>
          <a:xfrm>
            <a:off x="251787" y="210714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1600" b="1">
                <a:latin typeface="Arial" pitchFamily="34" charset="0"/>
                <a:cs typeface="Arial" pitchFamily="34" charset="0"/>
              </a:defRPr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  <a:lvl6pPr>
              <a:defRPr/>
            </a:lvl6pPr>
            <a:lvl7pPr>
              <a:defRPr/>
            </a:lvl7pPr>
            <a:lvl8pPr>
              <a:defRPr/>
            </a:lvl8pPr>
            <a:lvl9pPr>
              <a:defRPr/>
            </a:lvl9pPr>
          </a:lstStyle>
          <a:p>
            <a:r>
              <a:rPr lang="fr-FR" dirty="0" smtClean="0"/>
              <a:t>B</a:t>
            </a:r>
            <a:endParaRPr lang="fr-FR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84"/>
          <a:stretch/>
        </p:blipFill>
        <p:spPr bwMode="auto">
          <a:xfrm>
            <a:off x="276721" y="2445702"/>
            <a:ext cx="3999548" cy="42993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0" name="ZoneTexte 119"/>
          <p:cNvSpPr txBox="1"/>
          <p:nvPr/>
        </p:nvSpPr>
        <p:spPr>
          <a:xfrm>
            <a:off x="280040" y="18864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1600" b="1">
                <a:latin typeface="Arial" pitchFamily="34" charset="0"/>
                <a:cs typeface="Arial" pitchFamily="34" charset="0"/>
              </a:defRPr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  <a:lvl6pPr>
              <a:defRPr/>
            </a:lvl6pPr>
            <a:lvl7pPr>
              <a:defRPr/>
            </a:lvl7pPr>
            <a:lvl8pPr>
              <a:defRPr/>
            </a:lvl8pPr>
            <a:lvl9pPr>
              <a:defRPr/>
            </a:lvl9pPr>
          </a:lstStyle>
          <a:p>
            <a:r>
              <a:rPr lang="fr-FR" dirty="0" smtClean="0"/>
              <a:t>A</a:t>
            </a:r>
            <a:endParaRPr lang="fr-FR" dirty="0"/>
          </a:p>
        </p:txBody>
      </p:sp>
      <p:grpSp>
        <p:nvGrpSpPr>
          <p:cNvPr id="118" name="Groupe 117"/>
          <p:cNvGrpSpPr/>
          <p:nvPr/>
        </p:nvGrpSpPr>
        <p:grpSpPr>
          <a:xfrm>
            <a:off x="531249" y="501447"/>
            <a:ext cx="6023311" cy="1498160"/>
            <a:chOff x="302020" y="619651"/>
            <a:chExt cx="6023311" cy="1498160"/>
          </a:xfrm>
        </p:grpSpPr>
        <p:sp>
          <p:nvSpPr>
            <p:cNvPr id="77" name="ZoneTexte 76"/>
            <p:cNvSpPr txBox="1"/>
            <p:nvPr/>
          </p:nvSpPr>
          <p:spPr>
            <a:xfrm>
              <a:off x="531249" y="619651"/>
              <a:ext cx="15359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fr-FR" dirty="0" err="1" smtClean="0"/>
                <a:t>pMNGagPol</a:t>
              </a:r>
              <a:r>
                <a:rPr lang="fr-FR" dirty="0" smtClean="0"/>
                <a:t> (MLV_WT)</a:t>
              </a:r>
              <a:endParaRPr lang="fr-FR" dirty="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094065" y="1629912"/>
              <a:ext cx="43200" cy="183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3" name="Groupe 2"/>
            <p:cNvGrpSpPr/>
            <p:nvPr/>
          </p:nvGrpSpPr>
          <p:grpSpPr>
            <a:xfrm>
              <a:off x="2075140" y="652293"/>
              <a:ext cx="3632951" cy="420003"/>
              <a:chOff x="2075140" y="652293"/>
              <a:chExt cx="3632951" cy="420003"/>
            </a:xfrm>
          </p:grpSpPr>
          <p:sp>
            <p:nvSpPr>
              <p:cNvPr id="38" name="Rectangle 37"/>
              <p:cNvSpPr/>
              <p:nvPr/>
            </p:nvSpPr>
            <p:spPr>
              <a:xfrm>
                <a:off x="3327648" y="652293"/>
                <a:ext cx="900000" cy="2196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</a:t>
                </a:r>
                <a:endParaRPr lang="fr-FR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2860429" y="652293"/>
                <a:ext cx="468000" cy="2196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12</a:t>
                </a:r>
                <a:endParaRPr lang="fr-FR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2168180" y="652293"/>
                <a:ext cx="691734" cy="219251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</a:t>
                </a:r>
                <a:endParaRPr lang="fr-FR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riangle isocèle 40"/>
              <p:cNvSpPr/>
              <p:nvPr/>
            </p:nvSpPr>
            <p:spPr>
              <a:xfrm rot="5400000">
                <a:off x="2151523" y="683086"/>
                <a:ext cx="219227" cy="157641"/>
              </a:xfrm>
              <a:prstGeom prst="triangle">
                <a:avLst>
                  <a:gd name="adj" fmla="val 40776"/>
                </a:avLst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2075140" y="652293"/>
                <a:ext cx="114233" cy="21286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4223957" y="652293"/>
                <a:ext cx="792000" cy="2196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endParaRPr lang="fr-FR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5013293" y="652293"/>
                <a:ext cx="631395" cy="219251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L</a:t>
                </a:r>
                <a:endParaRPr lang="fr-FR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riangle isocèle 47"/>
              <p:cNvSpPr/>
              <p:nvPr/>
            </p:nvSpPr>
            <p:spPr>
              <a:xfrm rot="16200000">
                <a:off x="5456964" y="683086"/>
                <a:ext cx="219227" cy="157641"/>
              </a:xfrm>
              <a:prstGeom prst="triangle">
                <a:avLst>
                  <a:gd name="adj" fmla="val 40776"/>
                </a:avLst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5650975" y="652293"/>
                <a:ext cx="57116" cy="2184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50" name="ZoneTexte 49"/>
              <p:cNvSpPr txBox="1"/>
              <p:nvPr/>
            </p:nvSpPr>
            <p:spPr>
              <a:xfrm>
                <a:off x="4667792" y="887630"/>
                <a:ext cx="3589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600" b="1" dirty="0" smtClean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F1</a:t>
                </a:r>
                <a:endParaRPr lang="fr-FR" sz="600" b="1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4809869" y="652293"/>
                <a:ext cx="72536" cy="21925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84" name="Rectangle 83"/>
            <p:cNvSpPr/>
            <p:nvPr/>
          </p:nvSpPr>
          <p:spPr>
            <a:xfrm>
              <a:off x="3327632" y="1168388"/>
              <a:ext cx="900000" cy="21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84"/>
            <p:cNvSpPr/>
            <p:nvPr/>
          </p:nvSpPr>
          <p:spPr>
            <a:xfrm>
              <a:off x="2860413" y="1168388"/>
              <a:ext cx="468000" cy="21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12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2168164" y="1168737"/>
              <a:ext cx="691734" cy="21925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riangle isocèle 86"/>
            <p:cNvSpPr/>
            <p:nvPr/>
          </p:nvSpPr>
          <p:spPr>
            <a:xfrm rot="5400000">
              <a:off x="2151507" y="1199554"/>
              <a:ext cx="219227" cy="157641"/>
            </a:xfrm>
            <a:prstGeom prst="triangle">
              <a:avLst>
                <a:gd name="adj" fmla="val 40776"/>
              </a:avLst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075124" y="1175122"/>
              <a:ext cx="114233" cy="2128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4223941" y="1168388"/>
              <a:ext cx="792000" cy="21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Rectangle 89"/>
            <p:cNvSpPr/>
            <p:nvPr/>
          </p:nvSpPr>
          <p:spPr>
            <a:xfrm>
              <a:off x="5013277" y="1168737"/>
              <a:ext cx="631395" cy="21925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L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riangle isocèle 90"/>
            <p:cNvSpPr/>
            <p:nvPr/>
          </p:nvSpPr>
          <p:spPr>
            <a:xfrm rot="16200000">
              <a:off x="5456948" y="1199554"/>
              <a:ext cx="219227" cy="157641"/>
            </a:xfrm>
            <a:prstGeom prst="triangle">
              <a:avLst>
                <a:gd name="adj" fmla="val 40776"/>
              </a:avLst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Rectangle 91"/>
            <p:cNvSpPr/>
            <p:nvPr/>
          </p:nvSpPr>
          <p:spPr>
            <a:xfrm>
              <a:off x="5650959" y="1169555"/>
              <a:ext cx="57116" cy="2184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4672539" y="1401267"/>
              <a:ext cx="3589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600" b="1" dirty="0" smtClean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F1</a:t>
              </a:r>
              <a:endParaRPr lang="fr-FR" sz="6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Rectangle 93"/>
            <p:cNvSpPr/>
            <p:nvPr/>
          </p:nvSpPr>
          <p:spPr>
            <a:xfrm>
              <a:off x="4809853" y="1168737"/>
              <a:ext cx="72536" cy="21925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0" name="Connecteur droit 9"/>
            <p:cNvCxnSpPr/>
            <p:nvPr/>
          </p:nvCxnSpPr>
          <p:spPr>
            <a:xfrm flipV="1">
              <a:off x="3100958" y="1052736"/>
              <a:ext cx="16" cy="153756"/>
            </a:xfrm>
            <a:prstGeom prst="line">
              <a:avLst/>
            </a:prstGeom>
            <a:ln>
              <a:solidFill>
                <a:srgbClr val="C00000"/>
              </a:solidFill>
              <a:head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ZoneTexte 95"/>
            <p:cNvSpPr txBox="1"/>
            <p:nvPr/>
          </p:nvSpPr>
          <p:spPr>
            <a:xfrm>
              <a:off x="2931410" y="916370"/>
              <a:ext cx="3545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>
                <a:defRPr sz="6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fr-FR" dirty="0">
                  <a:solidFill>
                    <a:srgbClr val="C00000"/>
                  </a:solidFill>
                </a:rPr>
                <a:t>Not I</a:t>
              </a:r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2747189" y="1687539"/>
              <a:ext cx="425597" cy="21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12</a:t>
              </a: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2168148" y="1687888"/>
              <a:ext cx="691734" cy="21925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riangle isocèle 102"/>
            <p:cNvSpPr/>
            <p:nvPr/>
          </p:nvSpPr>
          <p:spPr>
            <a:xfrm rot="5400000">
              <a:off x="2151491" y="1718705"/>
              <a:ext cx="219227" cy="157641"/>
            </a:xfrm>
            <a:prstGeom prst="triangle">
              <a:avLst>
                <a:gd name="adj" fmla="val 40776"/>
              </a:avLst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Rectangle 103"/>
            <p:cNvSpPr/>
            <p:nvPr/>
          </p:nvSpPr>
          <p:spPr>
            <a:xfrm>
              <a:off x="2075108" y="1694273"/>
              <a:ext cx="114233" cy="2128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4841197" y="1687539"/>
              <a:ext cx="792000" cy="21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5630533" y="1687888"/>
              <a:ext cx="631395" cy="21925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L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riangle isocèle 106"/>
            <p:cNvSpPr/>
            <p:nvPr/>
          </p:nvSpPr>
          <p:spPr>
            <a:xfrm rot="16200000">
              <a:off x="6074204" y="1718705"/>
              <a:ext cx="219227" cy="157641"/>
            </a:xfrm>
            <a:prstGeom prst="triangle">
              <a:avLst>
                <a:gd name="adj" fmla="val 40776"/>
              </a:avLst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6268215" y="1688706"/>
              <a:ext cx="57116" cy="2184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5292075" y="1933145"/>
              <a:ext cx="3589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600" b="1" dirty="0" smtClean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F1</a:t>
              </a:r>
              <a:endParaRPr lang="fr-FR" sz="6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Rectangle 109"/>
            <p:cNvSpPr/>
            <p:nvPr/>
          </p:nvSpPr>
          <p:spPr>
            <a:xfrm>
              <a:off x="5427109" y="1687888"/>
              <a:ext cx="72536" cy="21925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3" name="Rectangle 112"/>
            <p:cNvSpPr/>
            <p:nvPr/>
          </p:nvSpPr>
          <p:spPr>
            <a:xfrm>
              <a:off x="3584848" y="1687539"/>
              <a:ext cx="467192" cy="21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12</a:t>
              </a:r>
            </a:p>
          </p:txBody>
        </p:sp>
        <p:sp>
          <p:nvSpPr>
            <p:cNvPr id="76" name="Rectangle 75"/>
            <p:cNvSpPr/>
            <p:nvPr/>
          </p:nvSpPr>
          <p:spPr>
            <a:xfrm>
              <a:off x="3098352" y="1688706"/>
              <a:ext cx="622795" cy="218433"/>
            </a:xfrm>
            <a:prstGeom prst="rect">
              <a:avLst/>
            </a:prstGeom>
            <a:solidFill>
              <a:schemeClr val="tx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2-coat</a:t>
              </a:r>
              <a:endParaRPr lang="fr-FR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3944888" y="1687539"/>
              <a:ext cx="900000" cy="21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</a:t>
              </a:r>
              <a:endParaRPr lang="fr-FR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Connecteur droit 115"/>
            <p:cNvCxnSpPr/>
            <p:nvPr/>
          </p:nvCxnSpPr>
          <p:spPr>
            <a:xfrm flipH="1">
              <a:off x="3099176" y="1148666"/>
              <a:ext cx="0" cy="219600"/>
            </a:xfrm>
            <a:prstGeom prst="line">
              <a:avLst/>
            </a:prstGeom>
            <a:ln w="9525">
              <a:solidFill>
                <a:srgbClr val="C0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ZoneTexte 120"/>
            <p:cNvSpPr txBox="1"/>
            <p:nvPr/>
          </p:nvSpPr>
          <p:spPr>
            <a:xfrm>
              <a:off x="875895" y="1089629"/>
              <a:ext cx="11913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fr-FR" dirty="0" smtClean="0"/>
                <a:t>pMNGagPol_ip12</a:t>
              </a:r>
            </a:p>
            <a:p>
              <a:pPr algn="r"/>
              <a:r>
                <a:rPr lang="fr-FR" dirty="0" smtClean="0"/>
                <a:t> (MLV_ip12)</a:t>
              </a:r>
              <a:endParaRPr lang="fr-FR" dirty="0"/>
            </a:p>
          </p:txBody>
        </p:sp>
        <p:sp>
          <p:nvSpPr>
            <p:cNvPr id="122" name="ZoneTexte 121"/>
            <p:cNvSpPr txBox="1"/>
            <p:nvPr/>
          </p:nvSpPr>
          <p:spPr>
            <a:xfrm>
              <a:off x="302020" y="1599497"/>
              <a:ext cx="176522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fr-FR" dirty="0" smtClean="0"/>
                <a:t>pMNGagPol_ip12_MS2coat</a:t>
              </a:r>
            </a:p>
            <a:p>
              <a:pPr algn="r"/>
              <a:r>
                <a:rPr lang="fr-FR" dirty="0" smtClean="0"/>
                <a:t> (MLV_ip12_MS2coat)</a:t>
              </a:r>
              <a:endParaRPr lang="fr-FR" dirty="0"/>
            </a:p>
          </p:txBody>
        </p:sp>
      </p:grpSp>
    </p:spTree>
    <p:extLst>
      <p:ext uri="{BB962C8B-B14F-4D97-AF65-F5344CB8AC3E}">
        <p14:creationId xmlns:p14="http://schemas.microsoft.com/office/powerpoint/2010/main" val="825453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52</Words>
  <Application>Microsoft Office PowerPoint</Application>
  <PresentationFormat>Format A4 (210 x 297 mm)</PresentationFormat>
  <Paragraphs>41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5273-2014-AP</dc:creator>
  <cp:lastModifiedBy>5273-2014-AP</cp:lastModifiedBy>
  <cp:revision>10</cp:revision>
  <cp:lastPrinted>2015-02-20T17:44:59Z</cp:lastPrinted>
  <dcterms:created xsi:type="dcterms:W3CDTF">2015-02-19T16:45:33Z</dcterms:created>
  <dcterms:modified xsi:type="dcterms:W3CDTF">2015-09-02T09:11:06Z</dcterms:modified>
</cp:coreProperties>
</file>